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4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9663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233" autoAdjust="0"/>
    <p:restoredTop sz="96076" autoAdjust="0"/>
  </p:normalViewPr>
  <p:slideViewPr>
    <p:cSldViewPr snapToGrid="0">
      <p:cViewPr>
        <p:scale>
          <a:sx n="70" d="100"/>
          <a:sy n="70" d="100"/>
        </p:scale>
        <p:origin x="2460" y="-4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161C01-9F1A-4548-8453-A45B4743FB18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069ED27-3606-498C-8CFF-22451B4E05B5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088682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1336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526247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971997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189586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298208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804227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405095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069187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892056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254867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755973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5D41C2-A700-42A2-B7BD-85C65B9212E5}" type="datetimeFigureOut">
              <a:rPr lang="fr-FR" smtClean="0"/>
              <a:t>17/01/2024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D9ABA7-F90B-4E70-A3E2-38108BB6540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579990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>
            <a:extLst>
              <a:ext uri="{FF2B5EF4-FFF2-40B4-BE49-F238E27FC236}">
                <a16:creationId xmlns:a16="http://schemas.microsoft.com/office/drawing/2014/main" id="{A1846473-A8B3-1880-101E-D90E30C4B8D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76325" y="1336545"/>
            <a:ext cx="5295900" cy="5320619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FFC235CA-4C2A-4EA7-8A29-7FC47A2A2E14}"/>
              </a:ext>
            </a:extLst>
          </p:cNvPr>
          <p:cNvSpPr/>
          <p:nvPr/>
        </p:nvSpPr>
        <p:spPr>
          <a:xfrm>
            <a:off x="198482" y="7165529"/>
            <a:ext cx="6277256" cy="21236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file 8: Figure S8.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isease severity of </a:t>
            </a:r>
            <a:r>
              <a:rPr lang="en-US" sz="11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. </a:t>
            </a:r>
            <a:r>
              <a:rPr lang="en-US" sz="1100" i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rassicicola</a:t>
            </a:r>
            <a:r>
              <a:rPr lang="en-US" sz="11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rain Ab43 and</a:t>
            </a:r>
            <a:r>
              <a:rPr lang="en-US" sz="11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. alternata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rains NB100 and NB66 on seedling tomato plant. A. Picture representing the disease severity of tomato seedlings after 10 d of inoculation by either Ab43, NB100, NB66, or water (control). B. Disease severity proportion of tomato seedling against Ab43, NB100 and NB66. Imbibed </a:t>
            </a:r>
            <a:r>
              <a:rPr lang="en-US" sz="11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ungerminated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omato seeds were inoculated by 1µL dropping inoculum of either </a:t>
            </a:r>
            <a:r>
              <a:rPr lang="en-US" sz="11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. </a:t>
            </a:r>
            <a:r>
              <a:rPr lang="en-US" sz="1100" i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rassicicola</a:t>
            </a:r>
            <a:r>
              <a:rPr lang="en-US" sz="11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rain Ab43 or </a:t>
            </a:r>
            <a:r>
              <a:rPr lang="en-US" sz="11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. </a:t>
            </a:r>
            <a:r>
              <a:rPr lang="en-US" sz="1100" i="1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lternata</a:t>
            </a:r>
            <a:r>
              <a:rPr lang="en-US" sz="11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rain NB100 and NB66 calibrated at 10</a:t>
            </a:r>
            <a:r>
              <a:rPr 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, 10</a:t>
            </a:r>
            <a:r>
              <a:rPr 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5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10</a:t>
            </a:r>
            <a:r>
              <a:rPr lang="en-US" sz="1100" baseline="30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6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FU/</a:t>
            </a:r>
            <a:r>
              <a:rPr lang="en-US" sz="1100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mL.</a:t>
            </a:r>
            <a:r>
              <a:rPr lang="en-US" sz="11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he inoculated seeds were incubated for ten days at 20°C in the light, after which a disease index was assigned to each seedling using a disease scale. 0-1: healthy seedling or very few symptoms; 2-3: small necrosis, partial browning of radicle and/or hypocotyl; 4-5: extensive necrosis, almost or total browning of radicle and/or hypocotyl. The data represent all measurements (n=30) of disease levels without taking into account the concentration factor and are expressed as a proportion (%) of the number of plants assigned to a disease index. </a:t>
            </a:r>
            <a:endParaRPr lang="fr-FR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107688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24</TotalTime>
  <Words>215</Words>
  <Application>Microsoft Office PowerPoint</Application>
  <PresentationFormat>Format A4 (210 x 297 mm)</PresentationFormat>
  <Paragraphs>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Hubert</dc:creator>
  <cp:lastModifiedBy>Julia Buitink</cp:lastModifiedBy>
  <cp:revision>115</cp:revision>
  <dcterms:created xsi:type="dcterms:W3CDTF">2023-08-10T14:53:51Z</dcterms:created>
  <dcterms:modified xsi:type="dcterms:W3CDTF">2024-01-17T14:40:15Z</dcterms:modified>
</cp:coreProperties>
</file>